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10.png" ContentType="image/png"/>
  <Override PartName="/ppt/media/image5.wmf" ContentType="image/x-wmf"/>
  <Override PartName="/ppt/media/image6.wmf" ContentType="image/x-wmf"/>
  <Override PartName="/ppt/media/image7.png" ContentType="image/png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184C4-25EF-4CF2-94BE-6A85BEC9F8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EFA24-ABE8-41D0-A3C4-F1B2E011D6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56F3B-45A8-4E31-9BCE-27E6062430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B43A4-55C5-46FA-8E81-50AFC1A923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2383A-4A2D-40AF-A710-4972A5C0F4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DF10B-BFFF-4148-BBF2-B3B8255F6A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1B01A-E774-4980-B88D-4254BBC155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0FE4A-193B-4A12-AF16-6B6D8C443D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0A4BDB-015F-4760-A256-FCEFCA1046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73B00-42BA-413D-9F4C-A57463A093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EF300-48E6-4432-B736-D3028C9E26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CCA02-323A-4D39-9945-F9B36C14DC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583C28-A64A-4D74-BDCA-DFF7C7AE527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png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44680" y="1239840"/>
            <a:ext cx="5762520" cy="5266080"/>
            <a:chOff x="544680" y="1239840"/>
            <a:chExt cx="5762520" cy="5266080"/>
          </a:xfrm>
        </p:grpSpPr>
        <p:pic>
          <p:nvPicPr>
            <p:cNvPr id="42" name="" descr=""/>
            <p:cNvPicPr/>
            <p:nvPr/>
          </p:nvPicPr>
          <p:blipFill>
            <a:blip r:embed="rId1">
              <a:lum contrast="42000"/>
            </a:blip>
            <a:srcRect l="0" t="7420" r="0" b="7774"/>
            <a:stretch/>
          </p:blipFill>
          <p:spPr>
            <a:xfrm>
              <a:off x="549360" y="1506600"/>
              <a:ext cx="503856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0" t="0" r="788" b="5042"/>
            <a:stretch/>
          </p:blipFill>
          <p:spPr>
            <a:xfrm>
              <a:off x="549360" y="2946240"/>
              <a:ext cx="5038560" cy="64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rcRect l="0" t="16352" r="2666" b="12718"/>
            <a:stretch/>
          </p:blipFill>
          <p:spPr>
            <a:xfrm>
              <a:off x="549360" y="4381560"/>
              <a:ext cx="503856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tretch/>
          </p:blipFill>
          <p:spPr>
            <a:xfrm>
              <a:off x="544680" y="1239840"/>
              <a:ext cx="503856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5"/>
            <a:stretch/>
          </p:blipFill>
          <p:spPr>
            <a:xfrm>
              <a:off x="560520" y="5567400"/>
              <a:ext cx="218916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6"/>
            <a:stretch/>
          </p:blipFill>
          <p:spPr>
            <a:xfrm>
              <a:off x="557280" y="4111560"/>
              <a:ext cx="502596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7"/>
            <a:srcRect l="2154" t="0" r="1042" b="5916"/>
            <a:stretch/>
          </p:blipFill>
          <p:spPr>
            <a:xfrm>
              <a:off x="2867040" y="5826240"/>
              <a:ext cx="174924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8"/>
            <a:stretch/>
          </p:blipFill>
          <p:spPr>
            <a:xfrm>
              <a:off x="2854440" y="5567400"/>
              <a:ext cx="17748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9"/>
            <a:stretch/>
          </p:blipFill>
          <p:spPr>
            <a:xfrm>
              <a:off x="574560" y="2678040"/>
              <a:ext cx="50292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10">
              <a:lum bright="12000"/>
            </a:blip>
            <a:srcRect l="0" t="0" r="0" b="5541"/>
            <a:stretch/>
          </p:blipFill>
          <p:spPr>
            <a:xfrm>
              <a:off x="549360" y="5823000"/>
              <a:ext cx="2165400" cy="647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"/>
            <p:cNvGrpSpPr/>
            <p:nvPr/>
          </p:nvGrpSpPr>
          <p:grpSpPr>
            <a:xfrm>
              <a:off x="5730840" y="1571760"/>
              <a:ext cx="576360" cy="200520"/>
              <a:chOff x="5730840" y="1571760"/>
              <a:chExt cx="576360" cy="200520"/>
            </a:xfrm>
          </p:grpSpPr>
          <p:sp>
            <p:nvSpPr>
              <p:cNvPr id="53" name=""/>
              <p:cNvSpPr/>
              <p:nvPr/>
            </p:nvSpPr>
            <p:spPr>
              <a:xfrm>
                <a:off x="5792760" y="157176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2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H="1">
                <a:off x="5730840" y="16714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5" name=""/>
            <p:cNvGrpSpPr/>
            <p:nvPr/>
          </p:nvGrpSpPr>
          <p:grpSpPr>
            <a:xfrm>
              <a:off x="5730840" y="1725480"/>
              <a:ext cx="576360" cy="200520"/>
              <a:chOff x="5730840" y="1725480"/>
              <a:chExt cx="576360" cy="200520"/>
            </a:xfrm>
          </p:grpSpPr>
          <p:sp>
            <p:nvSpPr>
              <p:cNvPr id="56" name=""/>
              <p:cNvSpPr/>
              <p:nvPr/>
            </p:nvSpPr>
            <p:spPr>
              <a:xfrm>
                <a:off x="5792760" y="172548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0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H="1">
                <a:off x="5730840" y="18255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"/>
            <p:cNvGrpSpPr/>
            <p:nvPr/>
          </p:nvGrpSpPr>
          <p:grpSpPr>
            <a:xfrm>
              <a:off x="5730840" y="1930320"/>
              <a:ext cx="576360" cy="200520"/>
              <a:chOff x="5730840" y="1930320"/>
              <a:chExt cx="576360" cy="200520"/>
            </a:xfrm>
          </p:grpSpPr>
          <p:sp>
            <p:nvSpPr>
              <p:cNvPr id="59" name=""/>
              <p:cNvSpPr/>
              <p:nvPr/>
            </p:nvSpPr>
            <p:spPr>
              <a:xfrm>
                <a:off x="5792760" y="193032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7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H="1">
                <a:off x="5730840" y="20304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"/>
            <p:cNvGrpSpPr/>
            <p:nvPr/>
          </p:nvGrpSpPr>
          <p:grpSpPr>
            <a:xfrm>
              <a:off x="5730840" y="1440000"/>
              <a:ext cx="576360" cy="200520"/>
              <a:chOff x="5730840" y="1440000"/>
              <a:chExt cx="576360" cy="200520"/>
            </a:xfrm>
          </p:grpSpPr>
          <p:sp>
            <p:nvSpPr>
              <p:cNvPr id="62" name=""/>
              <p:cNvSpPr/>
              <p:nvPr/>
            </p:nvSpPr>
            <p:spPr>
              <a:xfrm>
                <a:off x="5792760" y="144000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5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>
                <a:off x="5730840" y="15397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"/>
            <p:cNvGrpSpPr/>
            <p:nvPr/>
          </p:nvGrpSpPr>
          <p:grpSpPr>
            <a:xfrm>
              <a:off x="5721120" y="4552920"/>
              <a:ext cx="576000" cy="200520"/>
              <a:chOff x="5721120" y="4552920"/>
              <a:chExt cx="576000" cy="200520"/>
            </a:xfrm>
          </p:grpSpPr>
          <p:sp>
            <p:nvSpPr>
              <p:cNvPr id="65" name=""/>
              <p:cNvSpPr/>
              <p:nvPr/>
            </p:nvSpPr>
            <p:spPr>
              <a:xfrm>
                <a:off x="5783040" y="4552920"/>
                <a:ext cx="514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2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H="1">
                <a:off x="5721120" y="465264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" name=""/>
            <p:cNvGrpSpPr/>
            <p:nvPr/>
          </p:nvGrpSpPr>
          <p:grpSpPr>
            <a:xfrm>
              <a:off x="5721120" y="4697280"/>
              <a:ext cx="576000" cy="200520"/>
              <a:chOff x="5721120" y="4697280"/>
              <a:chExt cx="576000" cy="200520"/>
            </a:xfrm>
          </p:grpSpPr>
          <p:sp>
            <p:nvSpPr>
              <p:cNvPr id="68" name=""/>
              <p:cNvSpPr/>
              <p:nvPr/>
            </p:nvSpPr>
            <p:spPr>
              <a:xfrm>
                <a:off x="5783040" y="4697280"/>
                <a:ext cx="514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0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H="1">
                <a:off x="5721120" y="479736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0" name=""/>
            <p:cNvGrpSpPr/>
            <p:nvPr/>
          </p:nvGrpSpPr>
          <p:grpSpPr>
            <a:xfrm>
              <a:off x="5721120" y="4883040"/>
              <a:ext cx="576000" cy="200520"/>
              <a:chOff x="5721120" y="4883040"/>
              <a:chExt cx="576000" cy="200520"/>
            </a:xfrm>
          </p:grpSpPr>
          <p:sp>
            <p:nvSpPr>
              <p:cNvPr id="71" name=""/>
              <p:cNvSpPr/>
              <p:nvPr/>
            </p:nvSpPr>
            <p:spPr>
              <a:xfrm>
                <a:off x="5783040" y="4883040"/>
                <a:ext cx="514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7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H="1">
                <a:off x="5721120" y="498312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" name=""/>
            <p:cNvGrpSpPr/>
            <p:nvPr/>
          </p:nvGrpSpPr>
          <p:grpSpPr>
            <a:xfrm>
              <a:off x="5721120" y="4440240"/>
              <a:ext cx="576000" cy="200520"/>
              <a:chOff x="5721120" y="4440240"/>
              <a:chExt cx="576000" cy="200520"/>
            </a:xfrm>
          </p:grpSpPr>
          <p:sp>
            <p:nvSpPr>
              <p:cNvPr id="74" name=""/>
              <p:cNvSpPr/>
              <p:nvPr/>
            </p:nvSpPr>
            <p:spPr>
              <a:xfrm>
                <a:off x="5783040" y="4440240"/>
                <a:ext cx="514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5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H="1">
                <a:off x="5721120" y="454032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6" name=""/>
            <p:cNvGrpSpPr/>
            <p:nvPr/>
          </p:nvGrpSpPr>
          <p:grpSpPr>
            <a:xfrm>
              <a:off x="5726160" y="3033720"/>
              <a:ext cx="576360" cy="200520"/>
              <a:chOff x="5726160" y="3033720"/>
              <a:chExt cx="576360" cy="200520"/>
            </a:xfrm>
          </p:grpSpPr>
          <p:sp>
            <p:nvSpPr>
              <p:cNvPr id="77" name=""/>
              <p:cNvSpPr/>
              <p:nvPr/>
            </p:nvSpPr>
            <p:spPr>
              <a:xfrm>
                <a:off x="5788080" y="303372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2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H="1">
                <a:off x="5726160" y="31334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" name=""/>
            <p:cNvGrpSpPr/>
            <p:nvPr/>
          </p:nvGrpSpPr>
          <p:grpSpPr>
            <a:xfrm>
              <a:off x="5726160" y="3197160"/>
              <a:ext cx="576360" cy="200520"/>
              <a:chOff x="5726160" y="3197160"/>
              <a:chExt cx="576360" cy="200520"/>
            </a:xfrm>
          </p:grpSpPr>
          <p:sp>
            <p:nvSpPr>
              <p:cNvPr id="80" name=""/>
              <p:cNvSpPr/>
              <p:nvPr/>
            </p:nvSpPr>
            <p:spPr>
              <a:xfrm>
                <a:off x="5788080" y="319716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0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H="1">
                <a:off x="5726160" y="32972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2" name=""/>
            <p:cNvGrpSpPr/>
            <p:nvPr/>
          </p:nvGrpSpPr>
          <p:grpSpPr>
            <a:xfrm>
              <a:off x="5726160" y="3382920"/>
              <a:ext cx="576360" cy="200520"/>
              <a:chOff x="5726160" y="3382920"/>
              <a:chExt cx="576360" cy="200520"/>
            </a:xfrm>
          </p:grpSpPr>
          <p:sp>
            <p:nvSpPr>
              <p:cNvPr id="83" name=""/>
              <p:cNvSpPr/>
              <p:nvPr/>
            </p:nvSpPr>
            <p:spPr>
              <a:xfrm>
                <a:off x="5788080" y="338292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7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H="1">
                <a:off x="5726160" y="34830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5" name=""/>
            <p:cNvGrpSpPr/>
            <p:nvPr/>
          </p:nvGrpSpPr>
          <p:grpSpPr>
            <a:xfrm>
              <a:off x="5726160" y="2895480"/>
              <a:ext cx="576360" cy="200520"/>
              <a:chOff x="5726160" y="2895480"/>
              <a:chExt cx="576360" cy="200520"/>
            </a:xfrm>
          </p:grpSpPr>
          <p:sp>
            <p:nvSpPr>
              <p:cNvPr id="86" name=""/>
              <p:cNvSpPr/>
              <p:nvPr/>
            </p:nvSpPr>
            <p:spPr>
              <a:xfrm>
                <a:off x="5788080" y="289548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5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H="1">
                <a:off x="5726160" y="29955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" name=""/>
            <p:cNvGrpSpPr/>
            <p:nvPr/>
          </p:nvGrpSpPr>
          <p:grpSpPr>
            <a:xfrm>
              <a:off x="4672080" y="5908680"/>
              <a:ext cx="576360" cy="200520"/>
              <a:chOff x="4672080" y="5908680"/>
              <a:chExt cx="576360" cy="200520"/>
            </a:xfrm>
          </p:grpSpPr>
          <p:sp>
            <p:nvSpPr>
              <p:cNvPr id="89" name=""/>
              <p:cNvSpPr/>
              <p:nvPr/>
            </p:nvSpPr>
            <p:spPr>
              <a:xfrm>
                <a:off x="4734000" y="590868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2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H="1">
                <a:off x="4672080" y="60084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"/>
            <p:cNvGrpSpPr/>
            <p:nvPr/>
          </p:nvGrpSpPr>
          <p:grpSpPr>
            <a:xfrm>
              <a:off x="4672080" y="6076800"/>
              <a:ext cx="576360" cy="200520"/>
              <a:chOff x="4672080" y="6076800"/>
              <a:chExt cx="576360" cy="200520"/>
            </a:xfrm>
          </p:grpSpPr>
          <p:sp>
            <p:nvSpPr>
              <p:cNvPr id="92" name=""/>
              <p:cNvSpPr/>
              <p:nvPr/>
            </p:nvSpPr>
            <p:spPr>
              <a:xfrm>
                <a:off x="4734000" y="607680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0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 flipH="1">
                <a:off x="4672080" y="61768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" name=""/>
            <p:cNvGrpSpPr/>
            <p:nvPr/>
          </p:nvGrpSpPr>
          <p:grpSpPr>
            <a:xfrm>
              <a:off x="4672080" y="6305400"/>
              <a:ext cx="576360" cy="200520"/>
              <a:chOff x="4672080" y="6305400"/>
              <a:chExt cx="576360" cy="200520"/>
            </a:xfrm>
          </p:grpSpPr>
          <p:sp>
            <p:nvSpPr>
              <p:cNvPr id="95" name=""/>
              <p:cNvSpPr/>
              <p:nvPr/>
            </p:nvSpPr>
            <p:spPr>
              <a:xfrm>
                <a:off x="4734000" y="630540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75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H="1">
                <a:off x="4672080" y="64054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4672080" y="5767560"/>
              <a:ext cx="576360" cy="200520"/>
              <a:chOff x="4672080" y="5767560"/>
              <a:chExt cx="576360" cy="200520"/>
            </a:xfrm>
          </p:grpSpPr>
          <p:sp>
            <p:nvSpPr>
              <p:cNvPr id="98" name=""/>
              <p:cNvSpPr/>
              <p:nvPr/>
            </p:nvSpPr>
            <p:spPr>
              <a:xfrm>
                <a:off x="4734000" y="5767560"/>
                <a:ext cx="514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</a:rPr>
                  <a:t>150 pb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 flipH="1">
                <a:off x="4672080" y="58672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0" name=""/>
          <p:cNvSpPr/>
          <p:nvPr/>
        </p:nvSpPr>
        <p:spPr>
          <a:xfrm>
            <a:off x="307800" y="7742160"/>
            <a:ext cx="6324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 S1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 Separation of RT-PCR products on 4% (w/v) agarose gels revealed single products of the expected size for all reactions. Size standards (MW) in bp are shown on the right. Genes are listed in Supplementary Table S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28T11:56:56Z</dcterms:created>
  <dc:creator>IRDcafé</dc:creator>
  <dc:description/>
  <dc:language>en-US</dc:language>
  <cp:lastModifiedBy>joet</cp:lastModifiedBy>
  <dcterms:modified xsi:type="dcterms:W3CDTF">2008-12-01T07:00:50Z</dcterms:modified>
  <cp:revision>28</cp:revision>
  <dc:subject/>
  <dc:title>Diapositive 1</dc:title>
</cp:coreProperties>
</file>